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7" r:id="rId2"/>
    <p:sldId id="256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3622"/>
  </p:normalViewPr>
  <p:slideViewPr>
    <p:cSldViewPr snapToGrid="0">
      <p:cViewPr varScale="1">
        <p:scale>
          <a:sx n="68" d="100"/>
          <a:sy n="68" d="100"/>
        </p:scale>
        <p:origin x="34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C6FF6A-87F2-7D4C-B317-675B8385E2CB}" type="datetimeFigureOut">
              <a:rPr lang="en-US" smtClean="0"/>
              <a:t>8/25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F9A5F0-CA7B-9949-A2B5-3138680930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267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CC, 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erpin family B member 5</a:t>
            </a:r>
            <a:r>
              <a:rPr lang="en-US" dirty="0"/>
              <a:t> </a:t>
            </a:r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edicted to enable serine-type endopeptidase inhibitor activity. Predicted to be involved in negative regulation of endopeptidase activity. Predicted to act upstream of or within several processes, including extracellular matrix organization; prostate gland morphogenesis; and regulation of epithelial cell proliferation. Located in cytoplasm. Biomarker of hepatocellular carcinoma. [provided by Alliance of Genome Resources, Apr 2022]</a:t>
            </a:r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F9A5F0-CA7B-9949-A2B5-3138680930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926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F9A5F0-CA7B-9949-A2B5-3138680930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6941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F9A5F0-CA7B-9949-A2B5-31386809307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639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311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874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164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503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224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478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389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06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471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833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956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8A728B-A31A-9E4B-A828-BB4D39167A8D}" type="datetimeFigureOut">
              <a:rPr lang="en-US" smtClean="0"/>
              <a:t>8/25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CAD81-6903-344C-B15C-8F618459C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7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36BC32A-98EF-470D-E9EC-55DDE9765B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5850" y="-22860"/>
            <a:ext cx="5611864" cy="48101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E1FF9F6-7A73-752A-EDE1-CC94363A513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0000"/>
          <a:stretch/>
        </p:blipFill>
        <p:spPr>
          <a:xfrm>
            <a:off x="651643" y="4796790"/>
            <a:ext cx="2872740" cy="287274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6C83792-735A-56CF-8FD6-8BDB926EDF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87140" y="4796790"/>
            <a:ext cx="2872740" cy="28727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686447A-BC15-A2BF-7676-526126D82463}"/>
              </a:ext>
            </a:extLst>
          </p:cNvPr>
          <p:cNvSpPr txBox="1"/>
          <p:nvPr/>
        </p:nvSpPr>
        <p:spPr>
          <a:xfrm>
            <a:off x="0" y="7669530"/>
            <a:ext cx="67056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Methylation difference in cases and control for probes annotated to the gene SERPINB5.  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A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Each point represents the methylation of each sample. Lines link the mean methylation of each group. The leading edge panel shows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CPgs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 contributing to the ES in green and thos</a:t>
            </a:r>
            <a:r>
              <a:rPr lang="en-US" sz="1200" dirty="0">
                <a:solidFill>
                  <a:srgbClr val="2A2A2A"/>
                </a:solidFill>
                <a:latin typeface="Source Sans Pro" panose="020B0503030403020204" pitchFamily="34" charset="0"/>
              </a:rPr>
              <a:t>e not contributing in red  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B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Boxplot showing the subtle difference in methylation status between cases and controls 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C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GSEA plot. Vertical lines mark the location of SERPINB5 -associated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CpGs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 along the entire ranked list of analyzed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CpGs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 (horizontal black line). Red lines represent the maximum and minimum ES. This plot was obtained with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mCSEAPlotGSEA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) function, implemented in </a:t>
            </a:r>
            <a:r>
              <a:rPr lang="en-US" sz="1200" b="0" i="1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mCSEA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package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9A90A27-4965-979E-2AC7-F4D8B72BDE07}"/>
              </a:ext>
            </a:extLst>
          </p:cNvPr>
          <p:cNvSpPr txBox="1"/>
          <p:nvPr/>
        </p:nvSpPr>
        <p:spPr>
          <a:xfrm>
            <a:off x="160286" y="228600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B29CDC6-1B15-A756-780D-4C054602B007}"/>
              </a:ext>
            </a:extLst>
          </p:cNvPr>
          <p:cNvSpPr txBox="1"/>
          <p:nvPr/>
        </p:nvSpPr>
        <p:spPr>
          <a:xfrm>
            <a:off x="3552825" y="4925808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D2EC605-E21B-8033-167C-6896B5392EDF}"/>
              </a:ext>
            </a:extLst>
          </p:cNvPr>
          <p:cNvSpPr txBox="1"/>
          <p:nvPr/>
        </p:nvSpPr>
        <p:spPr>
          <a:xfrm>
            <a:off x="222465" y="4925808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84143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B59E7B89-3A9F-22D6-D06D-8002E8872F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6609" y="3936994"/>
            <a:ext cx="3047998" cy="304799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F232E0C-273C-4054-9648-C4A60FD04E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920" y="597932"/>
            <a:ext cx="5834479" cy="333398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153144C-0FC3-1285-A034-EF7BC6B1EAC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50000"/>
          <a:stretch/>
        </p:blipFill>
        <p:spPr>
          <a:xfrm>
            <a:off x="490537" y="4095750"/>
            <a:ext cx="3048000" cy="304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5285783-82E6-7569-3FF1-AE680FCF812A}"/>
              </a:ext>
            </a:extLst>
          </p:cNvPr>
          <p:cNvSpPr txBox="1"/>
          <p:nvPr/>
        </p:nvSpPr>
        <p:spPr>
          <a:xfrm>
            <a:off x="76200" y="7357170"/>
            <a:ext cx="670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Methylation difference in cases and control for probes annotated to the gene KLK14- kallikrein related peptidase 14.  Results are for the caudate   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A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Each point represents the methylation of each sample. Lines link the mean methylation of each group. The leading edge panel shows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CPgs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 contributing to the ES in green and thos</a:t>
            </a:r>
            <a:r>
              <a:rPr lang="en-US" sz="1200" dirty="0">
                <a:solidFill>
                  <a:srgbClr val="2A2A2A"/>
                </a:solidFill>
                <a:latin typeface="Source Sans Pro" panose="020B0503030403020204" pitchFamily="34" charset="0"/>
              </a:rPr>
              <a:t>e not contributing in red  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B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Boxplot showing the subtle difference in methylation status between cases and controls 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C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GSEA plot. 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91BCBEF-95E1-E113-EC18-DA7790F2909E}"/>
              </a:ext>
            </a:extLst>
          </p:cNvPr>
          <p:cNvSpPr txBox="1"/>
          <p:nvPr/>
        </p:nvSpPr>
        <p:spPr>
          <a:xfrm>
            <a:off x="160286" y="228600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7DC23CA-851A-DC64-7995-CFA70C2A73D1}"/>
              </a:ext>
            </a:extLst>
          </p:cNvPr>
          <p:cNvSpPr txBox="1"/>
          <p:nvPr/>
        </p:nvSpPr>
        <p:spPr>
          <a:xfrm>
            <a:off x="3552825" y="4925808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0E984C-57C5-46B2-BC26-2BFD1F8BE574}"/>
              </a:ext>
            </a:extLst>
          </p:cNvPr>
          <p:cNvSpPr txBox="1"/>
          <p:nvPr/>
        </p:nvSpPr>
        <p:spPr>
          <a:xfrm>
            <a:off x="222465" y="4925808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7601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9F8A508-A1F1-0142-E50E-06666F208C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2834" y="358140"/>
            <a:ext cx="5736566" cy="409754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BC78EC6-CE50-A929-499D-C4E11C5C395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0000"/>
          <a:stretch/>
        </p:blipFill>
        <p:spPr>
          <a:xfrm>
            <a:off x="533400" y="4455687"/>
            <a:ext cx="2895600" cy="28956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B679B60-0E97-B0C3-ECDA-519C3A867E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7458" y="4504832"/>
            <a:ext cx="2881942" cy="288194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2AA81F2-B628-50B5-DB6F-9A2C28C3D41D}"/>
              </a:ext>
            </a:extLst>
          </p:cNvPr>
          <p:cNvSpPr txBox="1"/>
          <p:nvPr/>
        </p:nvSpPr>
        <p:spPr>
          <a:xfrm>
            <a:off x="0" y="7770197"/>
            <a:ext cx="67056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Methylation difference in </a:t>
            </a:r>
            <a:r>
              <a:rPr lang="en-US" sz="1200" dirty="0">
                <a:solidFill>
                  <a:srgbClr val="2A2A2A"/>
                </a:solidFill>
                <a:latin typeface="Source Sans Pro" panose="020B0503030403020204" pitchFamily="34" charset="0"/>
              </a:rPr>
              <a:t>the caudate for 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cases and control for probes annotated to the gene PRDM8 </a:t>
            </a:r>
            <a:r>
              <a:rPr lang="en-US" sz="10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-</a:t>
            </a:r>
            <a:r>
              <a:rPr lang="en-US" sz="1000" dirty="0"/>
              <a:t>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R/SET domain 8</a:t>
            </a:r>
            <a:r>
              <a:rPr lang="en-US" sz="1000" dirty="0"/>
              <a:t>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his gene encodes a protein that belongs to a conserved family of histone methyltransferases that predominantly act as negative regulators of transcription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  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A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Each point represents the methylation of each sample. Lines link the mean methylation of each group. The leading edge panel shows </a:t>
            </a:r>
            <a:r>
              <a:rPr lang="en-US" sz="1200" b="0" i="0" dirty="0" err="1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CPgs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 contributing to the ES in green and thos</a:t>
            </a:r>
            <a:r>
              <a:rPr lang="en-US" sz="1200" dirty="0">
                <a:solidFill>
                  <a:srgbClr val="2A2A2A"/>
                </a:solidFill>
                <a:latin typeface="Source Sans Pro" panose="020B0503030403020204" pitchFamily="34" charset="0"/>
              </a:rPr>
              <a:t>e not contributing in red  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B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Boxplot showing the subtle difference in methylation status between cases and controls </a:t>
            </a:r>
            <a:r>
              <a:rPr lang="en-US" sz="1200" b="1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(C)</a:t>
            </a:r>
            <a:r>
              <a:rPr lang="en-US" sz="1200" b="0" i="0" dirty="0">
                <a:solidFill>
                  <a:srgbClr val="2A2A2A"/>
                </a:solidFill>
                <a:effectLst/>
                <a:latin typeface="Source Sans Pro" panose="020B0503030403020204" pitchFamily="34" charset="0"/>
              </a:rPr>
              <a:t> GSEA plot. </a:t>
            </a:r>
            <a:endParaRPr 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5A39928-9E42-E09D-FE8A-F49D75EDC9B9}"/>
              </a:ext>
            </a:extLst>
          </p:cNvPr>
          <p:cNvSpPr txBox="1"/>
          <p:nvPr/>
        </p:nvSpPr>
        <p:spPr>
          <a:xfrm>
            <a:off x="108165" y="487680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DA8C07C-A6EF-061D-10C9-4F81D8406B17}"/>
              </a:ext>
            </a:extLst>
          </p:cNvPr>
          <p:cNvSpPr txBox="1"/>
          <p:nvPr/>
        </p:nvSpPr>
        <p:spPr>
          <a:xfrm>
            <a:off x="3552825" y="4925808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1ED79D-E20B-EC11-E27B-9E74ACFEFCA7}"/>
              </a:ext>
            </a:extLst>
          </p:cNvPr>
          <p:cNvSpPr txBox="1"/>
          <p:nvPr/>
        </p:nvSpPr>
        <p:spPr>
          <a:xfrm>
            <a:off x="222465" y="4925808"/>
            <a:ext cx="677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60061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238</TotalTime>
  <Words>390</Words>
  <Application>Microsoft Macintosh PowerPoint</Application>
  <PresentationFormat>Letter Paper (8.5x11 in)</PresentationFormat>
  <Paragraphs>1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ource Sans Pro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dre, Gustavo (NIH/NHGRI) [E]</dc:creator>
  <cp:lastModifiedBy>Shaw, Philip (NIH/NHGRI) [E]</cp:lastModifiedBy>
  <cp:revision>5</cp:revision>
  <dcterms:created xsi:type="dcterms:W3CDTF">2023-08-25T15:57:00Z</dcterms:created>
  <dcterms:modified xsi:type="dcterms:W3CDTF">2023-08-28T14:42:58Z</dcterms:modified>
</cp:coreProperties>
</file>